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81" r:id="rId2"/>
  </p:sldIdLst>
  <p:sldSz cx="6400800" cy="2743200"/>
  <p:notesSz cx="6858000" cy="9144000"/>
  <p:defaultTextStyle>
    <a:defPPr>
      <a:defRPr lang="en-US"/>
    </a:defPPr>
    <a:lvl1pPr marL="0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1pPr>
    <a:lvl2pPr marL="417424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2pPr>
    <a:lvl3pPr marL="834847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3pPr>
    <a:lvl4pPr marL="1252271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4pPr>
    <a:lvl5pPr marL="1669694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5pPr>
    <a:lvl6pPr marL="2087118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6pPr>
    <a:lvl7pPr marL="2504542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7pPr>
    <a:lvl8pPr marL="2921965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8pPr>
    <a:lvl9pPr marL="3339389" algn="l" defTabSz="834847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2D6"/>
    <a:srgbClr val="FF40FF"/>
    <a:srgbClr val="00FA00"/>
    <a:srgbClr val="0432FF"/>
    <a:srgbClr val="FF9300"/>
    <a:srgbClr val="FF7E79"/>
    <a:srgbClr val="23B696"/>
    <a:srgbClr val="1B92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32"/>
    <p:restoredTop sz="96271"/>
  </p:normalViewPr>
  <p:slideViewPr>
    <p:cSldViewPr snapToGrid="0" snapToObjects="1">
      <p:cViewPr varScale="1">
        <p:scale>
          <a:sx n="188" d="100"/>
          <a:sy n="188" d="100"/>
        </p:scale>
        <p:origin x="176" y="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7CD9DA-01E2-804A-82F6-7AE6D8A49595}" type="datetimeFigureOut">
              <a:rPr lang="en-US" smtClean="0"/>
              <a:t>4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71450" y="1143000"/>
            <a:ext cx="7200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6844D9-CF7B-394F-BA05-4B6C43079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632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1pPr>
    <a:lvl2pPr marL="417424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2pPr>
    <a:lvl3pPr marL="834847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3pPr>
    <a:lvl4pPr marL="1252271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4pPr>
    <a:lvl5pPr marL="1669694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5pPr>
    <a:lvl6pPr marL="2087118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6pPr>
    <a:lvl7pPr marL="2504542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7pPr>
    <a:lvl8pPr marL="2921965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8pPr>
    <a:lvl9pPr marL="3339389" algn="l" defTabSz="834847" rtl="0" eaLnBrk="1" latinLnBrk="0" hangingPunct="1">
      <a:defRPr sz="109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0100" y="448945"/>
            <a:ext cx="4800600" cy="955040"/>
          </a:xfrm>
        </p:spPr>
        <p:txBody>
          <a:bodyPr anchor="b"/>
          <a:lstStyle>
            <a:lvl1pPr algn="ctr"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1440815"/>
            <a:ext cx="4800600" cy="662305"/>
          </a:xfrm>
        </p:spPr>
        <p:txBody>
          <a:bodyPr/>
          <a:lstStyle>
            <a:lvl1pPr marL="0" indent="0" algn="ctr">
              <a:buNone/>
              <a:defRPr sz="960"/>
            </a:lvl1pPr>
            <a:lvl2pPr marL="182880" indent="0" algn="ctr">
              <a:buNone/>
              <a:defRPr sz="800"/>
            </a:lvl2pPr>
            <a:lvl3pPr marL="365760" indent="0" algn="ctr">
              <a:buNone/>
              <a:defRPr sz="720"/>
            </a:lvl3pPr>
            <a:lvl4pPr marL="548640" indent="0" algn="ctr">
              <a:buNone/>
              <a:defRPr sz="640"/>
            </a:lvl4pPr>
            <a:lvl5pPr marL="731520" indent="0" algn="ctr">
              <a:buNone/>
              <a:defRPr sz="640"/>
            </a:lvl5pPr>
            <a:lvl6pPr marL="914400" indent="0" algn="ctr">
              <a:buNone/>
              <a:defRPr sz="640"/>
            </a:lvl6pPr>
            <a:lvl7pPr marL="1097280" indent="0" algn="ctr">
              <a:buNone/>
              <a:defRPr sz="640"/>
            </a:lvl7pPr>
            <a:lvl8pPr marL="1280160" indent="0" algn="ctr">
              <a:buNone/>
              <a:defRPr sz="640"/>
            </a:lvl8pPr>
            <a:lvl9pPr marL="1463040" indent="0" algn="ctr">
              <a:buNone/>
              <a:defRPr sz="6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723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700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2" y="146050"/>
            <a:ext cx="1380173" cy="23247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146050"/>
            <a:ext cx="4060508" cy="232473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520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530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1" y="683895"/>
            <a:ext cx="5520690" cy="114109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1" y="1835785"/>
            <a:ext cx="5520690" cy="600075"/>
          </a:xfrm>
        </p:spPr>
        <p:txBody>
          <a:bodyPr/>
          <a:lstStyle>
            <a:lvl1pPr marL="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1pPr>
            <a:lvl2pPr marL="18288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2pPr>
            <a:lvl3pPr marL="365760" indent="0">
              <a:buNone/>
              <a:defRPr sz="720">
                <a:solidFill>
                  <a:schemeClr val="tx1">
                    <a:tint val="75000"/>
                  </a:schemeClr>
                </a:solidFill>
              </a:defRPr>
            </a:lvl3pPr>
            <a:lvl4pPr marL="5486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4pPr>
            <a:lvl5pPr marL="73152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5pPr>
            <a:lvl6pPr marL="91440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6pPr>
            <a:lvl7pPr marL="109728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7pPr>
            <a:lvl8pPr marL="128016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8pPr>
            <a:lvl9pPr marL="1463040" indent="0">
              <a:buNone/>
              <a:defRPr sz="6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286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730250"/>
            <a:ext cx="2720340" cy="17405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730250"/>
            <a:ext cx="2720340" cy="17405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944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46050"/>
            <a:ext cx="5520690" cy="5302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672465"/>
            <a:ext cx="2707838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1002030"/>
            <a:ext cx="2707838" cy="14738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672465"/>
            <a:ext cx="2721174" cy="329565"/>
          </a:xfrm>
        </p:spPr>
        <p:txBody>
          <a:bodyPr anchor="b"/>
          <a:lstStyle>
            <a:lvl1pPr marL="0" indent="0">
              <a:buNone/>
              <a:defRPr sz="960" b="1"/>
            </a:lvl1pPr>
            <a:lvl2pPr marL="182880" indent="0">
              <a:buNone/>
              <a:defRPr sz="800" b="1"/>
            </a:lvl2pPr>
            <a:lvl3pPr marL="365760" indent="0">
              <a:buNone/>
              <a:defRPr sz="720" b="1"/>
            </a:lvl3pPr>
            <a:lvl4pPr marL="548640" indent="0">
              <a:buNone/>
              <a:defRPr sz="640" b="1"/>
            </a:lvl4pPr>
            <a:lvl5pPr marL="731520" indent="0">
              <a:buNone/>
              <a:defRPr sz="640" b="1"/>
            </a:lvl5pPr>
            <a:lvl6pPr marL="914400" indent="0">
              <a:buNone/>
              <a:defRPr sz="640" b="1"/>
            </a:lvl6pPr>
            <a:lvl7pPr marL="1097280" indent="0">
              <a:buNone/>
              <a:defRPr sz="640" b="1"/>
            </a:lvl7pPr>
            <a:lvl8pPr marL="1280160" indent="0">
              <a:buNone/>
              <a:defRPr sz="640" b="1"/>
            </a:lvl8pPr>
            <a:lvl9pPr marL="1463040" indent="0">
              <a:buNone/>
              <a:defRPr sz="6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1002030"/>
            <a:ext cx="2721174" cy="147383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52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43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0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82880"/>
            <a:ext cx="2064424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394970"/>
            <a:ext cx="3240405" cy="1949450"/>
          </a:xfrm>
        </p:spPr>
        <p:txBody>
          <a:bodyPr/>
          <a:lstStyle>
            <a:lvl1pPr>
              <a:defRPr sz="1280"/>
            </a:lvl1pPr>
            <a:lvl2pPr>
              <a:defRPr sz="1120"/>
            </a:lvl2pPr>
            <a:lvl3pPr>
              <a:defRPr sz="96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822960"/>
            <a:ext cx="2064424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921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182880"/>
            <a:ext cx="2064424" cy="640080"/>
          </a:xfrm>
        </p:spPr>
        <p:txBody>
          <a:bodyPr anchor="b"/>
          <a:lstStyle>
            <a:lvl1pPr>
              <a:defRPr sz="12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394970"/>
            <a:ext cx="3240405" cy="1949450"/>
          </a:xfrm>
        </p:spPr>
        <p:txBody>
          <a:bodyPr anchor="t"/>
          <a:lstStyle>
            <a:lvl1pPr marL="0" indent="0">
              <a:buNone/>
              <a:defRPr sz="1280"/>
            </a:lvl1pPr>
            <a:lvl2pPr marL="182880" indent="0">
              <a:buNone/>
              <a:defRPr sz="1120"/>
            </a:lvl2pPr>
            <a:lvl3pPr marL="365760" indent="0">
              <a:buNone/>
              <a:defRPr sz="960"/>
            </a:lvl3pPr>
            <a:lvl4pPr marL="548640" indent="0">
              <a:buNone/>
              <a:defRPr sz="800"/>
            </a:lvl4pPr>
            <a:lvl5pPr marL="731520" indent="0">
              <a:buNone/>
              <a:defRPr sz="800"/>
            </a:lvl5pPr>
            <a:lvl6pPr marL="914400" indent="0">
              <a:buNone/>
              <a:defRPr sz="800"/>
            </a:lvl6pPr>
            <a:lvl7pPr marL="1097280" indent="0">
              <a:buNone/>
              <a:defRPr sz="800"/>
            </a:lvl7pPr>
            <a:lvl8pPr marL="1280160" indent="0">
              <a:buNone/>
              <a:defRPr sz="800"/>
            </a:lvl8pPr>
            <a:lvl9pPr marL="1463040" indent="0">
              <a:buNone/>
              <a:defRPr sz="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822960"/>
            <a:ext cx="2064424" cy="1524635"/>
          </a:xfrm>
        </p:spPr>
        <p:txBody>
          <a:bodyPr/>
          <a:lstStyle>
            <a:lvl1pPr marL="0" indent="0">
              <a:buNone/>
              <a:defRPr sz="640"/>
            </a:lvl1pPr>
            <a:lvl2pPr marL="182880" indent="0">
              <a:buNone/>
              <a:defRPr sz="560"/>
            </a:lvl2pPr>
            <a:lvl3pPr marL="365760" indent="0">
              <a:buNone/>
              <a:defRPr sz="480"/>
            </a:lvl3pPr>
            <a:lvl4pPr marL="548640" indent="0">
              <a:buNone/>
              <a:defRPr sz="400"/>
            </a:lvl4pPr>
            <a:lvl5pPr marL="731520" indent="0">
              <a:buNone/>
              <a:defRPr sz="400"/>
            </a:lvl5pPr>
            <a:lvl6pPr marL="914400" indent="0">
              <a:buNone/>
              <a:defRPr sz="400"/>
            </a:lvl6pPr>
            <a:lvl7pPr marL="1097280" indent="0">
              <a:buNone/>
              <a:defRPr sz="400"/>
            </a:lvl7pPr>
            <a:lvl8pPr marL="1280160" indent="0">
              <a:buNone/>
              <a:defRPr sz="400"/>
            </a:lvl8pPr>
            <a:lvl9pPr marL="1463040" indent="0">
              <a:buNone/>
              <a:defRPr sz="4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146050"/>
            <a:ext cx="5520690" cy="53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730250"/>
            <a:ext cx="5520690" cy="17405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2542540"/>
            <a:ext cx="144018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B9724-28F0-B84F-89B2-F5D9320323B0}" type="datetimeFigureOut">
              <a:rPr lang="en-US" smtClean="0"/>
              <a:t>4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2542540"/>
            <a:ext cx="216027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2542540"/>
            <a:ext cx="1440180" cy="146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8BCA4-EA11-1148-AE4B-D5FDFB14F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207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365760" rtl="0" eaLnBrk="1" latinLnBrk="0" hangingPunct="1">
        <a:lnSpc>
          <a:spcPct val="90000"/>
        </a:lnSpc>
        <a:spcBef>
          <a:spcPct val="0"/>
        </a:spcBef>
        <a:buNone/>
        <a:defRPr sz="17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36576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12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" indent="-91440" algn="l" defTabSz="365760" rtl="0" eaLnBrk="1" latinLnBrk="0" hangingPunct="1">
        <a:lnSpc>
          <a:spcPct val="90000"/>
        </a:lnSpc>
        <a:spcBef>
          <a:spcPts val="20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" algn="l" defTabSz="365760" rtl="0" eaLnBrk="1" latinLnBrk="0" hangingPunct="1">
        <a:defRPr sz="7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9" t="28095" r="53275" b="34948"/>
          <a:stretch/>
        </p:blipFill>
        <p:spPr>
          <a:xfrm>
            <a:off x="389211" y="724641"/>
            <a:ext cx="2435704" cy="195849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8894986">
            <a:off x="542394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7</a:t>
            </a:r>
          </a:p>
        </p:txBody>
      </p:sp>
      <p:sp>
        <p:nvSpPr>
          <p:cNvPr id="6" name="TextBox 5"/>
          <p:cNvSpPr txBox="1"/>
          <p:nvPr/>
        </p:nvSpPr>
        <p:spPr>
          <a:xfrm rot="18894986">
            <a:off x="729255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a</a:t>
            </a:r>
          </a:p>
        </p:txBody>
      </p:sp>
      <p:sp>
        <p:nvSpPr>
          <p:cNvPr id="7" name="TextBox 6"/>
          <p:cNvSpPr txBox="1"/>
          <p:nvPr/>
        </p:nvSpPr>
        <p:spPr>
          <a:xfrm rot="18894986">
            <a:off x="916116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26</a:t>
            </a:r>
          </a:p>
        </p:txBody>
      </p:sp>
      <p:sp>
        <p:nvSpPr>
          <p:cNvPr id="8" name="TextBox 7"/>
          <p:cNvSpPr txBox="1"/>
          <p:nvPr/>
        </p:nvSpPr>
        <p:spPr>
          <a:xfrm rot="18894986">
            <a:off x="1102977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a</a:t>
            </a:r>
          </a:p>
        </p:txBody>
      </p:sp>
      <p:sp>
        <p:nvSpPr>
          <p:cNvPr id="9" name="TextBox 8"/>
          <p:cNvSpPr txBox="1"/>
          <p:nvPr/>
        </p:nvSpPr>
        <p:spPr>
          <a:xfrm rot="18894986">
            <a:off x="1289838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2a</a:t>
            </a:r>
          </a:p>
        </p:txBody>
      </p:sp>
      <p:sp>
        <p:nvSpPr>
          <p:cNvPr id="10" name="TextBox 9"/>
          <p:cNvSpPr txBox="1"/>
          <p:nvPr/>
        </p:nvSpPr>
        <p:spPr>
          <a:xfrm rot="18894986">
            <a:off x="1476699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3a</a:t>
            </a:r>
          </a:p>
        </p:txBody>
      </p:sp>
      <p:sp>
        <p:nvSpPr>
          <p:cNvPr id="11" name="TextBox 10"/>
          <p:cNvSpPr txBox="1"/>
          <p:nvPr/>
        </p:nvSpPr>
        <p:spPr>
          <a:xfrm rot="18894986">
            <a:off x="1671702" y="287235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Unselected</a:t>
            </a:r>
          </a:p>
        </p:txBody>
      </p:sp>
      <p:sp>
        <p:nvSpPr>
          <p:cNvPr id="12" name="TextBox 11"/>
          <p:cNvSpPr txBox="1"/>
          <p:nvPr/>
        </p:nvSpPr>
        <p:spPr>
          <a:xfrm rot="18894986">
            <a:off x="1882789" y="36045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8a</a:t>
            </a:r>
          </a:p>
        </p:txBody>
      </p:sp>
      <p:sp>
        <p:nvSpPr>
          <p:cNvPr id="13" name="TextBox 12"/>
          <p:cNvSpPr txBox="1"/>
          <p:nvPr/>
        </p:nvSpPr>
        <p:spPr>
          <a:xfrm rot="18894986">
            <a:off x="2118958" y="42402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14" name="TextBox 13"/>
          <p:cNvSpPr txBox="1"/>
          <p:nvPr/>
        </p:nvSpPr>
        <p:spPr>
          <a:xfrm rot="18894986">
            <a:off x="2290592" y="413237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>
                <a:latin typeface="Arial" charset="0"/>
                <a:ea typeface="Arial" charset="0"/>
                <a:cs typeface="Arial" charset="0"/>
              </a:rPr>
              <a:t>R32</a:t>
            </a:r>
            <a:endParaRPr lang="en-US" sz="8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8894986">
            <a:off x="2413482" y="231045"/>
            <a:ext cx="8883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Plasmid control</a:t>
            </a:r>
          </a:p>
        </p:txBody>
      </p:sp>
      <p:sp>
        <p:nvSpPr>
          <p:cNvPr id="16" name="TextBox 15"/>
          <p:cNvSpPr txBox="1"/>
          <p:nvPr/>
        </p:nvSpPr>
        <p:spPr>
          <a:xfrm rot="18894986">
            <a:off x="3416063" y="369135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9a</a:t>
            </a:r>
          </a:p>
        </p:txBody>
      </p:sp>
      <p:sp>
        <p:nvSpPr>
          <p:cNvPr id="17" name="TextBox 16"/>
          <p:cNvSpPr txBox="1"/>
          <p:nvPr/>
        </p:nvSpPr>
        <p:spPr>
          <a:xfrm rot="18894986">
            <a:off x="3630714" y="348703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0a</a:t>
            </a:r>
          </a:p>
        </p:txBody>
      </p:sp>
      <p:sp>
        <p:nvSpPr>
          <p:cNvPr id="18" name="TextBox 17"/>
          <p:cNvSpPr txBox="1"/>
          <p:nvPr/>
        </p:nvSpPr>
        <p:spPr>
          <a:xfrm rot="18894986">
            <a:off x="3854521" y="369135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7</a:t>
            </a:r>
          </a:p>
        </p:txBody>
      </p:sp>
      <p:sp>
        <p:nvSpPr>
          <p:cNvPr id="20" name="TextBox 19"/>
          <p:cNvSpPr txBox="1"/>
          <p:nvPr/>
        </p:nvSpPr>
        <p:spPr>
          <a:xfrm rot="18894986">
            <a:off x="4061825" y="369135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5a</a:t>
            </a:r>
          </a:p>
        </p:txBody>
      </p:sp>
      <p:sp>
        <p:nvSpPr>
          <p:cNvPr id="21" name="TextBox 20"/>
          <p:cNvSpPr txBox="1"/>
          <p:nvPr/>
        </p:nvSpPr>
        <p:spPr>
          <a:xfrm rot="18894986">
            <a:off x="4309908" y="369135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3a</a:t>
            </a:r>
          </a:p>
        </p:txBody>
      </p:sp>
      <p:sp>
        <p:nvSpPr>
          <p:cNvPr id="22" name="TextBox 21"/>
          <p:cNvSpPr txBox="1"/>
          <p:nvPr/>
        </p:nvSpPr>
        <p:spPr>
          <a:xfrm rot="18894986">
            <a:off x="4510861" y="344730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8a</a:t>
            </a:r>
          </a:p>
        </p:txBody>
      </p:sp>
      <p:sp>
        <p:nvSpPr>
          <p:cNvPr id="23" name="TextBox 22"/>
          <p:cNvSpPr txBox="1"/>
          <p:nvPr/>
        </p:nvSpPr>
        <p:spPr>
          <a:xfrm rot="18894986">
            <a:off x="4751880" y="348703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19a</a:t>
            </a:r>
          </a:p>
        </p:txBody>
      </p:sp>
      <p:sp>
        <p:nvSpPr>
          <p:cNvPr id="24" name="TextBox 23"/>
          <p:cNvSpPr txBox="1"/>
          <p:nvPr/>
        </p:nvSpPr>
        <p:spPr>
          <a:xfrm rot="18894986">
            <a:off x="4984040" y="369135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als1-6a</a:t>
            </a:r>
          </a:p>
        </p:txBody>
      </p:sp>
      <p:sp>
        <p:nvSpPr>
          <p:cNvPr id="25" name="TextBox 24"/>
          <p:cNvSpPr txBox="1"/>
          <p:nvPr/>
        </p:nvSpPr>
        <p:spPr>
          <a:xfrm rot="18894986">
            <a:off x="5455573" y="42192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>
                <a:latin typeface="Arial" charset="0"/>
                <a:ea typeface="Arial" charset="0"/>
                <a:cs typeface="Arial" charset="0"/>
              </a:rPr>
              <a:t>R32</a:t>
            </a:r>
            <a:endParaRPr lang="en-US" sz="8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8894986">
            <a:off x="5594647" y="239728"/>
            <a:ext cx="8883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Plasmid control</a:t>
            </a:r>
          </a:p>
        </p:txBody>
      </p:sp>
      <p:sp>
        <p:nvSpPr>
          <p:cNvPr id="27" name="TextBox 26"/>
          <p:cNvSpPr txBox="1"/>
          <p:nvPr/>
        </p:nvSpPr>
        <p:spPr>
          <a:xfrm rot="18894986">
            <a:off x="5234707" y="43270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98" t="29011" r="8773" b="34032"/>
          <a:stretch/>
        </p:blipFill>
        <p:spPr>
          <a:xfrm>
            <a:off x="3213730" y="724641"/>
            <a:ext cx="2731449" cy="1958495"/>
          </a:xfrm>
          <a:prstGeom prst="rect">
            <a:avLst/>
          </a:prstGeom>
        </p:spPr>
      </p:pic>
      <p:cxnSp>
        <p:nvCxnSpPr>
          <p:cNvPr id="30" name="Straight Connector 29"/>
          <p:cNvCxnSpPr/>
          <p:nvPr/>
        </p:nvCxnSpPr>
        <p:spPr>
          <a:xfrm flipV="1">
            <a:off x="72981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91458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110744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292215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149316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V="1">
            <a:off x="1677935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184651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203937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223223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241700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V="1">
            <a:off x="260986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V="1">
            <a:off x="3568763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V="1">
            <a:off x="3793991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V="1">
            <a:off x="401921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V="1">
            <a:off x="424444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4469675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4694903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V="1">
            <a:off x="4920131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5145359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5370587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V="1">
            <a:off x="5595815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5821043" y="6801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7450" y="50919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bp</a:t>
            </a:r>
          </a:p>
        </p:txBody>
      </p:sp>
      <p:cxnSp>
        <p:nvCxnSpPr>
          <p:cNvPr id="55" name="Straight Connector 54"/>
          <p:cNvCxnSpPr/>
          <p:nvPr/>
        </p:nvCxnSpPr>
        <p:spPr>
          <a:xfrm rot="5400000" flipV="1">
            <a:off x="371075" y="1188580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rot="5400000" flipV="1">
            <a:off x="371075" y="1947880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rot="5400000" flipV="1">
            <a:off x="371075" y="2100280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rot="5400000" flipV="1">
            <a:off x="371075" y="2285048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39347" y="110072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charset="0"/>
                <a:ea typeface="Arial" charset="0"/>
                <a:cs typeface="Arial" charset="0"/>
              </a:rPr>
              <a:t>21.2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9347" y="186129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charset="0"/>
                <a:ea typeface="Arial" charset="0"/>
                <a:cs typeface="Arial" charset="0"/>
              </a:rPr>
              <a:t>5.1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9347" y="20056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.9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39347" y="222274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.2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879954" y="50919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kbp</a:t>
            </a:r>
          </a:p>
        </p:txBody>
      </p:sp>
      <p:cxnSp>
        <p:nvCxnSpPr>
          <p:cNvPr id="64" name="Straight Connector 63"/>
          <p:cNvCxnSpPr/>
          <p:nvPr/>
        </p:nvCxnSpPr>
        <p:spPr>
          <a:xfrm rot="5400000" flipV="1">
            <a:off x="3193579" y="1125564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rot="5400000" flipV="1">
            <a:off x="3193579" y="1884864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rot="5400000" flipV="1">
            <a:off x="3193579" y="2037264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rot="5400000" flipV="1">
            <a:off x="3193579" y="222203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2861851" y="103770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charset="0"/>
                <a:ea typeface="Arial" charset="0"/>
                <a:cs typeface="Arial" charset="0"/>
              </a:rPr>
              <a:t>21.2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861851" y="17982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charset="0"/>
                <a:ea typeface="Arial" charset="0"/>
                <a:cs typeface="Arial" charset="0"/>
              </a:rPr>
              <a:t>5.1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861851" y="194259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.9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861851" y="215972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.2</a:t>
            </a:r>
          </a:p>
        </p:txBody>
      </p:sp>
    </p:spTree>
    <p:extLst>
      <p:ext uri="{BB962C8B-B14F-4D97-AF65-F5344CB8AC3E}">
        <p14:creationId xmlns:p14="http://schemas.microsoft.com/office/powerpoint/2010/main" val="1546202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973</TotalTime>
  <Words>34</Words>
  <Application>Microsoft Macintosh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e Kwan Ko</dc:creator>
  <cp:lastModifiedBy>Dae Kwan Ko</cp:lastModifiedBy>
  <cp:revision>416</cp:revision>
  <dcterms:created xsi:type="dcterms:W3CDTF">2017-06-23T16:58:21Z</dcterms:created>
  <dcterms:modified xsi:type="dcterms:W3CDTF">2018-04-06T01:03:05Z</dcterms:modified>
</cp:coreProperties>
</file>